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3" autoAdjust="0"/>
    <p:restoredTop sz="94660"/>
  </p:normalViewPr>
  <p:slideViewPr>
    <p:cSldViewPr snapToGrid="0">
      <p:cViewPr>
        <p:scale>
          <a:sx n="90" d="100"/>
          <a:sy n="90" d="100"/>
        </p:scale>
        <p:origin x="1020" y="52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C0733FA-5F03-42C0-9E21-1E7A690FCF6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A6E8C3A7-E59D-4AEB-B29E-CFAC9D9CDF9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21AD704-1D78-4522-815D-DB36A11DA7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A08DAC5B-79D8-4787-8E7F-08F6D5F24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70A002B-7C44-4EDB-B109-EE183F9EB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976021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D25C1F-088C-464F-8094-9CDBE058F66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AA90564-7F8D-43F6-9C17-392D31294B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29549B-BEF4-4F90-BC71-7B62FC4BB4A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76ABA0A-77B9-4510-8351-36F5E4F608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705F435-013E-41E8-BEB4-1BC81D38C2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651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A950084A-7245-4559-9494-0172B53C54A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2F1AAA50-8F7C-4592-87A9-F63949FCA3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A3CDD94-C9EB-4665-9B7C-F6F552642B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BF2BE31-5A58-439D-B712-B4C88E8A13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46EAF11-C6DC-4BCB-BE06-2DEA12E2A8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59239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CE49E21-E09F-4DFD-9F84-DA719E6CCB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A308818-2225-4DF2-9722-280F7F36471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F6B0E62A-3D1E-416C-8993-2291BB7D39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7B15BC7A-E9FE-441A-95E8-2DDE6BDC17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F717627-3AF6-4403-BF78-044320C84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209376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0E36D8D-5E32-4D42-8FB3-9068D00888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41B28961-534F-40AF-8B1E-B817D231816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8F0A58-6FC7-47CB-A465-57FB7BA595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BA8A1886-2FD3-46E6-8506-CFA80063C9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C1EEDA3-F737-46FE-AD72-74FF413255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304342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3CAAE90-889D-4C20-A39D-7E6B4B6AC0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A1BBB718-26F4-4F7F-A1F6-516C0650CC6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61BEEC1-1D40-44B9-93CD-8108B509B5C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B7114B09-70CF-452D-8633-5B4593FC5F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9F7F39A-13EA-4D0B-9E56-1D21E62BDE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78888ED-DD6A-494A-8BEC-39A365461E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359238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7CA69F-91B5-45B2-9AFF-541197198C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6BB139B-1A21-491A-917C-A53BAD6B912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6CFE5363-A14D-496B-8081-2C796C7106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EDD4EF0C-BD73-4975-9FAC-1B2BCC91775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44AA4D84-A148-4920-B601-DC4CF0EB42A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525CD749-F4B3-41C0-86EA-8939863EB2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7ED63E57-D35E-49E8-BC89-AD7D2DCAA4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B40DEF9-4AE5-481C-8C81-2F7CB015CA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3363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7292605-CBE2-403F-96AC-C6C49F98E8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E7A8E76-34F3-4D64-B697-32BF91B508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19A409FA-D156-45AB-87B6-471CD09849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5A2119DC-4609-4EC9-AB20-60B619A9A1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827679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6FDC9BB8-82E4-4CD9-BD9E-DDAB1DBA73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41F8716F-CAC5-4412-A846-4BAD4EC1EA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C0519A81-F3F2-41BD-97C5-ED421458BF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8086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13E9013-D74D-4543-83BA-46F87028E66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7070E07-F471-4087-AD52-7D5B7E3C4F4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856DDF4-99D0-439B-A839-73118AC92C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6E16C8A8-9AD0-4403-86F1-5346B12432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00D2634-1D62-42EC-93E8-53B23F4631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64C225F-3ACD-4C07-95B1-9B824CCF15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36166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CC1DA9B-C091-4483-9AE5-89219B9742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2639104-3EC5-48E5-A0E3-6DDF7B61C03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3F05445-6A61-4C5B-9425-4D8B74782A7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F7C04A3-AFE6-4ED9-81E2-75B70ECA0D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17F6A74F-421D-4F46-9E4C-C5DFEED0C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40D2BBD-D8E2-4777-8ABE-86940E544B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35341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8337C454-B7F1-414A-AD3E-1867E085ED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032F16F-996F-41C1-9726-DEC7632D957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836F0C2-D961-45A7-9D3F-3B5D04F5F77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BE4A3E-92E7-4D52-A1D7-DA6217415D4D}" type="datetimeFigureOut">
              <a:rPr kumimoji="1" lang="ja-JP" altLang="en-US" smtClean="0"/>
              <a:t>2025/12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F2735AF-AC06-4E55-B689-6E2DF7C723F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CD88ACE-5D55-4D9F-913A-7AAC9927C52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8CFDBE-EB72-4077-BB48-34336FD1A49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40413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表 1">
            <a:extLst>
              <a:ext uri="{FF2B5EF4-FFF2-40B4-BE49-F238E27FC236}">
                <a16:creationId xmlns:a16="http://schemas.microsoft.com/office/drawing/2014/main" id="{6E6E92DC-CEA2-4B35-89DC-EC5ED973CDE6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8174348"/>
              </p:ext>
            </p:extLst>
          </p:nvPr>
        </p:nvGraphicFramePr>
        <p:xfrm>
          <a:off x="691122" y="1158943"/>
          <a:ext cx="10792047" cy="4351335"/>
        </p:xfrm>
        <a:graphic>
          <a:graphicData uri="http://schemas.openxmlformats.org/drawingml/2006/table">
            <a:tbl>
              <a:tblPr/>
              <a:tblGrid>
                <a:gridCol w="701749">
                  <a:extLst>
                    <a:ext uri="{9D8B030D-6E8A-4147-A177-3AD203B41FA5}">
                      <a16:colId xmlns:a16="http://schemas.microsoft.com/office/drawing/2014/main" val="3767448863"/>
                    </a:ext>
                  </a:extLst>
                </a:gridCol>
                <a:gridCol w="733647">
                  <a:extLst>
                    <a:ext uri="{9D8B030D-6E8A-4147-A177-3AD203B41FA5}">
                      <a16:colId xmlns:a16="http://schemas.microsoft.com/office/drawing/2014/main" val="3704313733"/>
                    </a:ext>
                  </a:extLst>
                </a:gridCol>
                <a:gridCol w="712381">
                  <a:extLst>
                    <a:ext uri="{9D8B030D-6E8A-4147-A177-3AD203B41FA5}">
                      <a16:colId xmlns:a16="http://schemas.microsoft.com/office/drawing/2014/main" val="1332891409"/>
                    </a:ext>
                  </a:extLst>
                </a:gridCol>
                <a:gridCol w="712382">
                  <a:extLst>
                    <a:ext uri="{9D8B030D-6E8A-4147-A177-3AD203B41FA5}">
                      <a16:colId xmlns:a16="http://schemas.microsoft.com/office/drawing/2014/main" val="705908294"/>
                    </a:ext>
                  </a:extLst>
                </a:gridCol>
                <a:gridCol w="723014">
                  <a:extLst>
                    <a:ext uri="{9D8B030D-6E8A-4147-A177-3AD203B41FA5}">
                      <a16:colId xmlns:a16="http://schemas.microsoft.com/office/drawing/2014/main" val="1994445855"/>
                    </a:ext>
                  </a:extLst>
                </a:gridCol>
                <a:gridCol w="723013">
                  <a:extLst>
                    <a:ext uri="{9D8B030D-6E8A-4147-A177-3AD203B41FA5}">
                      <a16:colId xmlns:a16="http://schemas.microsoft.com/office/drawing/2014/main" val="2694656621"/>
                    </a:ext>
                  </a:extLst>
                </a:gridCol>
                <a:gridCol w="723014">
                  <a:extLst>
                    <a:ext uri="{9D8B030D-6E8A-4147-A177-3AD203B41FA5}">
                      <a16:colId xmlns:a16="http://schemas.microsoft.com/office/drawing/2014/main" val="3847529440"/>
                    </a:ext>
                  </a:extLst>
                </a:gridCol>
                <a:gridCol w="1073889">
                  <a:extLst>
                    <a:ext uri="{9D8B030D-6E8A-4147-A177-3AD203B41FA5}">
                      <a16:colId xmlns:a16="http://schemas.microsoft.com/office/drawing/2014/main" val="3443842857"/>
                    </a:ext>
                  </a:extLst>
                </a:gridCol>
                <a:gridCol w="1084521">
                  <a:extLst>
                    <a:ext uri="{9D8B030D-6E8A-4147-A177-3AD203B41FA5}">
                      <a16:colId xmlns:a16="http://schemas.microsoft.com/office/drawing/2014/main" val="2741927604"/>
                    </a:ext>
                  </a:extLst>
                </a:gridCol>
                <a:gridCol w="1073888">
                  <a:extLst>
                    <a:ext uri="{9D8B030D-6E8A-4147-A177-3AD203B41FA5}">
                      <a16:colId xmlns:a16="http://schemas.microsoft.com/office/drawing/2014/main" val="2838912205"/>
                    </a:ext>
                  </a:extLst>
                </a:gridCol>
                <a:gridCol w="723014">
                  <a:extLst>
                    <a:ext uri="{9D8B030D-6E8A-4147-A177-3AD203B41FA5}">
                      <a16:colId xmlns:a16="http://schemas.microsoft.com/office/drawing/2014/main" val="2022400042"/>
                    </a:ext>
                  </a:extLst>
                </a:gridCol>
                <a:gridCol w="733647">
                  <a:extLst>
                    <a:ext uri="{9D8B030D-6E8A-4147-A177-3AD203B41FA5}">
                      <a16:colId xmlns:a16="http://schemas.microsoft.com/office/drawing/2014/main" val="2759076932"/>
                    </a:ext>
                  </a:extLst>
                </a:gridCol>
                <a:gridCol w="1073888">
                  <a:extLst>
                    <a:ext uri="{9D8B030D-6E8A-4147-A177-3AD203B41FA5}">
                      <a16:colId xmlns:a16="http://schemas.microsoft.com/office/drawing/2014/main" val="1933561849"/>
                    </a:ext>
                  </a:extLst>
                </a:gridCol>
              </a:tblGrid>
              <a:tr h="916071"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tient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ge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years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ravidit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arit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eight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cm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eight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kg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MI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kg/m²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nstrual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cle (days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ndometrioma size (cm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teralit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ASRM</a:t>
                      </a:r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tage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MH</a:t>
                      </a:r>
                    </a:p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ng/mL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reatment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9762364"/>
                  </a:ext>
                </a:extLst>
              </a:tr>
              <a:tr h="572544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8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–28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ight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3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paroscop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18315353"/>
                  </a:ext>
                </a:extLst>
              </a:tr>
              <a:tr h="572544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7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8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1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–3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 (R), 4 (L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ateral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6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paroscop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5447739"/>
                  </a:ext>
                </a:extLst>
              </a:tr>
              <a:tr h="572544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–31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88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lerotherap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0050448"/>
                  </a:ext>
                </a:extLst>
              </a:tr>
              <a:tr h="572544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59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1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–3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eft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6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lerotherap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2937313"/>
                  </a:ext>
                </a:extLst>
              </a:tr>
              <a:tr h="572544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9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–29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R), 6 (L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ateral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V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2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aparoscop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0994238"/>
                  </a:ext>
                </a:extLst>
              </a:tr>
              <a:tr h="572544"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7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4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3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–27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 (R), 4 (L)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lateral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II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ja-JP" sz="100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24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0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clerotherapy</a:t>
                      </a:r>
                    </a:p>
                  </a:txBody>
                  <a:tcPr marL="57254" marR="57254" marT="28627" marB="28627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4356024"/>
                  </a:ext>
                </a:extLst>
              </a:tr>
            </a:tbl>
          </a:graphicData>
        </a:graphic>
      </p:graphicFrame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D34CD2A8-4244-4916-B921-CE1417E5F78D}"/>
              </a:ext>
            </a:extLst>
          </p:cNvPr>
          <p:cNvSpPr/>
          <p:nvPr/>
        </p:nvSpPr>
        <p:spPr>
          <a:xfrm>
            <a:off x="3256900" y="470256"/>
            <a:ext cx="5639232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Supplementary Table 1</a:t>
            </a:r>
            <a:endParaRPr kumimoji="0" lang="en-US" altLang="ja-JP" sz="14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400" b="1" dirty="0">
                <a:latin typeface="Arial" panose="020B0604020202020204" pitchFamily="34" charset="0"/>
                <a:cs typeface="Arial" panose="020B0604020202020204" pitchFamily="34" charset="0"/>
              </a:rPr>
              <a:t>Clinical characteristics of patients providing endometrioma fluid</a:t>
            </a:r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5D3084A-07E5-4AE3-A268-9A771A459CF0}"/>
              </a:ext>
            </a:extLst>
          </p:cNvPr>
          <p:cNvSpPr/>
          <p:nvPr/>
        </p:nvSpPr>
        <p:spPr>
          <a:xfrm>
            <a:off x="1032956" y="6013001"/>
            <a:ext cx="1008712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kumimoji="0" lang="ja-JP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Abbreviations:</a:t>
            </a:r>
            <a:r>
              <a:rPr kumimoji="0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0" lang="ja-JP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BMI, body mass index; AMH, anti-Müllerian hormone; rASRM, revised American Society for Reproductive Medicine; R, right; L, left.</a:t>
            </a:r>
            <a:endParaRPr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56AA2FC3-E36B-4DE2-B795-3ED773DA9878}"/>
              </a:ext>
            </a:extLst>
          </p:cNvPr>
          <p:cNvCxnSpPr/>
          <p:nvPr/>
        </p:nvCxnSpPr>
        <p:spPr>
          <a:xfrm>
            <a:off x="691122" y="1233374"/>
            <a:ext cx="10792047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" name="直線コネクタ 11">
            <a:extLst>
              <a:ext uri="{FF2B5EF4-FFF2-40B4-BE49-F238E27FC236}">
                <a16:creationId xmlns:a16="http://schemas.microsoft.com/office/drawing/2014/main" id="{0D9E26FD-DB05-416C-A046-34DD206C0674}"/>
              </a:ext>
            </a:extLst>
          </p:cNvPr>
          <p:cNvCxnSpPr/>
          <p:nvPr/>
        </p:nvCxnSpPr>
        <p:spPr>
          <a:xfrm>
            <a:off x="680494" y="2013097"/>
            <a:ext cx="10792047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直線コネクタ 12">
            <a:extLst>
              <a:ext uri="{FF2B5EF4-FFF2-40B4-BE49-F238E27FC236}">
                <a16:creationId xmlns:a16="http://schemas.microsoft.com/office/drawing/2014/main" id="{17487FB5-B487-45F2-8EA0-23FAD61546ED}"/>
              </a:ext>
            </a:extLst>
          </p:cNvPr>
          <p:cNvCxnSpPr/>
          <p:nvPr/>
        </p:nvCxnSpPr>
        <p:spPr>
          <a:xfrm>
            <a:off x="684032" y="5599820"/>
            <a:ext cx="10792047" cy="0"/>
          </a:xfrm>
          <a:prstGeom prst="line">
            <a:avLst/>
          </a:prstGeom>
          <a:ln w="19050">
            <a:solidFill>
              <a:schemeClr val="tx1"/>
            </a:solidFill>
            <a:prstDash val="soli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84449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84</Words>
  <Application>Microsoft Office PowerPoint</Application>
  <PresentationFormat>ワイド画面</PresentationFormat>
  <Paragraphs>10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ser</dc:creator>
  <cp:lastModifiedBy>user</cp:lastModifiedBy>
  <cp:revision>7</cp:revision>
  <dcterms:created xsi:type="dcterms:W3CDTF">2025-12-19T02:22:18Z</dcterms:created>
  <dcterms:modified xsi:type="dcterms:W3CDTF">2025-12-19T02:56:08Z</dcterms:modified>
</cp:coreProperties>
</file>